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LB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5204"/>
  </p:normalViewPr>
  <p:slideViewPr>
    <p:cSldViewPr snapToGrid="0" snapToObjects="1">
      <p:cViewPr>
        <p:scale>
          <a:sx n="93" d="100"/>
          <a:sy n="93" d="100"/>
        </p:scale>
        <p:origin x="144" y="2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129B729-E391-6900-AF56-1A2294F085E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EEBE5BB-9041-E17B-5405-B8B2E393D87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145DBA2-74EB-459A-7D6F-126BB0D677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00DB3-E1E4-9043-BA1C-AAA12319511A}" type="datetimeFigureOut">
              <a:rPr lang="en-US" smtClean="0"/>
              <a:t>6/1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DD5A8C1-CD9F-D41A-1522-984DB71C98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FF29257-4941-0BFE-4264-DDC9C91DB0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5A4C0-51A3-7E4E-87ED-65194BF588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0604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3DD8DB-A95D-9E8E-A3FA-42C7578C509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288765F-916E-150F-9F6C-D18E09CE711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E4EA821-704C-1584-C87D-D591CA02C3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00DB3-E1E4-9043-BA1C-AAA12319511A}" type="datetimeFigureOut">
              <a:rPr lang="en-US" smtClean="0"/>
              <a:t>6/1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C38CA64-F7D4-F5C0-8C0F-0F0B439DA2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D827FEB-D173-28CA-B8FC-8B609BDC24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5A4C0-51A3-7E4E-87ED-65194BF588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71917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9629463-96A5-6DD4-586B-48687A7FF94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49CCE94-3675-080C-A434-359E321EAA9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7B5F12D-0DF3-DF2C-16C1-8E6F74AFEE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00DB3-E1E4-9043-BA1C-AAA12319511A}" type="datetimeFigureOut">
              <a:rPr lang="en-US" smtClean="0"/>
              <a:t>6/1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2AD9B32-1C7E-DA56-F437-B909E270EF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06BC8C7-8024-103A-BC3C-6BF22F6CB5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5A4C0-51A3-7E4E-87ED-65194BF588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30845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403F4D-0BE3-5601-6A4B-3060855B150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282700C-721D-69B9-C19B-CD879808C34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F651298-D096-42FB-A84E-A3C71FF44A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00DB3-E1E4-9043-BA1C-AAA12319511A}" type="datetimeFigureOut">
              <a:rPr lang="en-US" smtClean="0"/>
              <a:t>6/1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34487C9-2577-0DAD-B7D1-F22C5642B0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95A7CE0-E953-DFBD-D950-FCBF0D4D0A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5A4C0-51A3-7E4E-87ED-65194BF588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35876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3B64C4-CF37-BAF8-F113-9137E3D7378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3A4BC19-6E2E-DD2D-9AD7-976483EF326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61AEE02-B642-4C79-6963-5C988B663A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00DB3-E1E4-9043-BA1C-AAA12319511A}" type="datetimeFigureOut">
              <a:rPr lang="en-US" smtClean="0"/>
              <a:t>6/1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4FF17C3-0465-CA93-DE2F-74746380DB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199251A-2EDA-F996-9D5D-339F9C6F30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5A4C0-51A3-7E4E-87ED-65194BF588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34531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357251-94FC-8D9A-DAA0-2D612ED6C84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6DF0608-2687-9281-9F75-25A4F4DC4FB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403EE7D-57C4-617C-FF62-F53FB406D71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9D61054-41E6-7E1A-8368-4F1FD57683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00DB3-E1E4-9043-BA1C-AAA12319511A}" type="datetimeFigureOut">
              <a:rPr lang="en-US" smtClean="0"/>
              <a:t>6/10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0B10D4B-DBE6-78C0-8048-4A2D6E1C40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59B6B21-DA08-3FFA-35DC-9FBEC09DFD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5A4C0-51A3-7E4E-87ED-65194BF588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04442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928FC8-53E0-83DD-ACC1-6F402C801C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1695E07-97CA-EDF3-BCB6-4F069D10C20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014E29F-59D4-1513-8A1A-9F571F2EBAC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71DC11D-9861-F9AD-24AE-B532B7EF34B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9DA4811-6E5D-7ED9-EF26-0647685520A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6C7335F-C079-62D0-B528-6E175278D5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00DB3-E1E4-9043-BA1C-AAA12319511A}" type="datetimeFigureOut">
              <a:rPr lang="en-US" smtClean="0"/>
              <a:t>6/10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178C5EE-B4BF-677B-FC4E-7C56406CA1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47C7C55-FF6A-79C5-3668-8D0610E079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5A4C0-51A3-7E4E-87ED-65194BF588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92268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CFA0A7-053F-BFED-2894-CA2EAA29E2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01A84D1-D947-4D2C-8EC2-EC315596D7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00DB3-E1E4-9043-BA1C-AAA12319511A}" type="datetimeFigureOut">
              <a:rPr lang="en-US" smtClean="0"/>
              <a:t>6/10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7B97AF1-919E-EEC9-4886-4EB6E79DF0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509BD1C-2CE1-1172-B175-45B577225B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5A4C0-51A3-7E4E-87ED-65194BF588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91383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6607EC5-7167-5489-9999-B86C0E20AF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00DB3-E1E4-9043-BA1C-AAA12319511A}" type="datetimeFigureOut">
              <a:rPr lang="en-US" smtClean="0"/>
              <a:t>6/10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925B6A2-9702-A93F-1A36-AB4DF97903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B28E1F5-35DB-5D1A-83C7-F8E5D91068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5A4C0-51A3-7E4E-87ED-65194BF588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43675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C4EEA4-E8C3-7893-A078-5B628EC9E14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20385D7-9AA9-5FD2-8E47-C67DEE773B2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1FBB218-3CEA-D41C-E1BD-2628188CE2B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DD3D137-6D20-E5E1-6984-B3C4E3A1D8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00DB3-E1E4-9043-BA1C-AAA12319511A}" type="datetimeFigureOut">
              <a:rPr lang="en-US" smtClean="0"/>
              <a:t>6/10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9CC99AE-B37D-0200-DC43-89D4A87CD2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057C3CD-B89E-16E3-ECA4-607C779F21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5A4C0-51A3-7E4E-87ED-65194BF588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68564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1FB05C-194B-F802-0EF6-8DE1FF005B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AE0FACB-3FCF-BEBE-5117-9F26451908F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AB2C426-F2BB-5470-029F-D0B3DB7D9E3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BA831F8-6223-4CA7-9E0C-7DCBD74C1A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00DB3-E1E4-9043-BA1C-AAA12319511A}" type="datetimeFigureOut">
              <a:rPr lang="en-US" smtClean="0"/>
              <a:t>6/10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858A799-5A93-9351-8C7E-C3B3A21D9B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08693E2-7E10-1916-8C49-168DA5CA64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5A4C0-51A3-7E4E-87ED-65194BF588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77536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B78673D-C1B4-247E-0CE6-84A429092D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6C44769-77DD-5A60-13CA-CB791CFB564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0B20AD5-701C-8664-2A22-33C1DCC11FE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400DB3-E1E4-9043-BA1C-AAA12319511A}" type="datetimeFigureOut">
              <a:rPr lang="en-US" smtClean="0"/>
              <a:t>6/1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29F3142-90F7-73CE-3F49-07023365675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89481B7-FE34-F2E1-E3FD-A5B8635DA0E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85A4C0-51A3-7E4E-87ED-65194BF588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5336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LB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Picture 14" descr="Chart, diagram&#10;&#10;Description automatically generated">
            <a:extLst>
              <a:ext uri="{FF2B5EF4-FFF2-40B4-BE49-F238E27FC236}">
                <a16:creationId xmlns:a16="http://schemas.microsoft.com/office/drawing/2014/main" id="{4F52FB03-CBBE-BC32-CE4A-659C3491C98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67000" y="0"/>
            <a:ext cx="6858000" cy="6858000"/>
          </a:xfrm>
          <a:prstGeom prst="rect">
            <a:avLst/>
          </a:prstGeom>
        </p:spPr>
      </p:pic>
      <p:sp>
        <p:nvSpPr>
          <p:cNvPr id="3" name="Subtitle 2">
            <a:extLst>
              <a:ext uri="{FF2B5EF4-FFF2-40B4-BE49-F238E27FC236}">
                <a16:creationId xmlns:a16="http://schemas.microsoft.com/office/drawing/2014/main" id="{93F16BEC-121F-39F3-A357-9DDB3E8EE28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898073" y="6423225"/>
            <a:ext cx="7786255" cy="450273"/>
          </a:xfrm>
        </p:spPr>
        <p:txBody>
          <a:bodyPr>
            <a:normAutofit/>
          </a:bodyPr>
          <a:lstStyle/>
          <a:p>
            <a:r>
              <a:rPr lang="en-US" sz="1200" b="1"/>
              <a:t>Figure S6. </a:t>
            </a:r>
            <a:r>
              <a:rPr lang="en-US" sz="1200" dirty="0"/>
              <a:t>BRIG comparison of the </a:t>
            </a:r>
            <a:r>
              <a:rPr lang="en-US" sz="1200" dirty="0" err="1"/>
              <a:t>IncN</a:t>
            </a:r>
            <a:r>
              <a:rPr lang="en-US" sz="1200" dirty="0"/>
              <a:t> plasmids harboring </a:t>
            </a:r>
            <a:r>
              <a:rPr lang="en-US" sz="1200" i="1" dirty="0" err="1"/>
              <a:t>bla</a:t>
            </a:r>
            <a:r>
              <a:rPr lang="en-US" sz="1200" baseline="-25000" dirty="0" err="1"/>
              <a:t>VIM</a:t>
            </a:r>
            <a:r>
              <a:rPr lang="en-US" sz="1200" baseline="-25000" dirty="0"/>
              <a:t>  </a:t>
            </a:r>
            <a:r>
              <a:rPr lang="en-US" sz="1200" dirty="0"/>
              <a:t>gene isolated in the Czech Republic.</a:t>
            </a:r>
          </a:p>
        </p:txBody>
      </p:sp>
    </p:spTree>
    <p:extLst>
      <p:ext uri="{BB962C8B-B14F-4D97-AF65-F5344CB8AC3E}">
        <p14:creationId xmlns:p14="http://schemas.microsoft.com/office/powerpoint/2010/main" val="25407972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0</TotalTime>
  <Words>18</Words>
  <Application>Microsoft Macintosh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brahim bitar</dc:creator>
  <cp:lastModifiedBy>ibrahim bitar</cp:lastModifiedBy>
  <cp:revision>7</cp:revision>
  <dcterms:created xsi:type="dcterms:W3CDTF">2022-06-10T08:29:36Z</dcterms:created>
  <dcterms:modified xsi:type="dcterms:W3CDTF">2022-06-10T09:09:57Z</dcterms:modified>
</cp:coreProperties>
</file>